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248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91439" cy="91439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055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170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766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022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193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366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012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795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360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672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210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2303A-0F63-4F8C-9360-14A4E614F61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437FBA-1AEC-4289-8742-F5F648603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695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>
            <a:extLst>
              <a:ext uri="{FF2B5EF4-FFF2-40B4-BE49-F238E27FC236}">
                <a16:creationId xmlns:a16="http://schemas.microsoft.com/office/drawing/2014/main" id="{8AAEEDE2-C59C-4BA8-9CE6-48EE363213F4}"/>
              </a:ext>
            </a:extLst>
          </p:cNvPr>
          <p:cNvGrpSpPr/>
          <p:nvPr/>
        </p:nvGrpSpPr>
        <p:grpSpPr>
          <a:xfrm>
            <a:off x="1114372" y="3477335"/>
            <a:ext cx="4600011" cy="3373743"/>
            <a:chOff x="928225" y="4294409"/>
            <a:chExt cx="4814958" cy="4418949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3AED8DC2-4E20-4D75-B084-A2B6C729B908}"/>
                </a:ext>
              </a:extLst>
            </p:cNvPr>
            <p:cNvGrpSpPr/>
            <p:nvPr/>
          </p:nvGrpSpPr>
          <p:grpSpPr>
            <a:xfrm>
              <a:off x="1342261" y="4294409"/>
              <a:ext cx="4400922" cy="4418949"/>
              <a:chOff x="1150296" y="308148"/>
              <a:chExt cx="4400922" cy="4418949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D49D0D4D-F22C-416F-BFB4-833C8A444D46}"/>
                  </a:ext>
                </a:extLst>
              </p:cNvPr>
              <p:cNvGrpSpPr/>
              <p:nvPr/>
            </p:nvGrpSpPr>
            <p:grpSpPr>
              <a:xfrm>
                <a:off x="1150296" y="308148"/>
                <a:ext cx="4400922" cy="4418949"/>
                <a:chOff x="1166408" y="431864"/>
                <a:chExt cx="4400922" cy="4418949"/>
              </a:xfrm>
            </p:grpSpPr>
            <p:cxnSp>
              <p:nvCxnSpPr>
                <p:cNvPr id="5" name="Straight Connector 4">
                  <a:extLst>
                    <a:ext uri="{FF2B5EF4-FFF2-40B4-BE49-F238E27FC236}">
                      <a16:creationId xmlns:a16="http://schemas.microsoft.com/office/drawing/2014/main" id="{26EDB637-BF01-4C50-872E-DF3A809F078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231005" y="989519"/>
                  <a:ext cx="0" cy="275555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" name="Straight Connector 6">
                  <a:extLst>
                    <a:ext uri="{FF2B5EF4-FFF2-40B4-BE49-F238E27FC236}">
                      <a16:creationId xmlns:a16="http://schemas.microsoft.com/office/drawing/2014/main" id="{803D271A-B70D-4D74-B62F-75E9741EED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231006" y="3729835"/>
                  <a:ext cx="3336324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C143B092-7F58-4868-9E9A-4B97FDA98426}"/>
                    </a:ext>
                  </a:extLst>
                </p:cNvPr>
                <p:cNvSpPr txBox="1"/>
                <p:nvPr/>
              </p:nvSpPr>
              <p:spPr>
                <a:xfrm rot="16200000">
                  <a:off x="-514771" y="2113043"/>
                  <a:ext cx="3781163" cy="4188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umber of Tat molecules detected </a:t>
                  </a:r>
                </a:p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er 10</a:t>
                  </a:r>
                  <a:r>
                    <a:rPr lang="en-US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 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l-G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 copies</a:t>
                  </a:r>
                </a:p>
              </p:txBody>
            </p:sp>
            <p:sp>
              <p:nvSpPr>
                <p:cNvPr id="18" name="Rectangle 17">
                  <a:extLst>
                    <a:ext uri="{FF2B5EF4-FFF2-40B4-BE49-F238E27FC236}">
                      <a16:creationId xmlns:a16="http://schemas.microsoft.com/office/drawing/2014/main" id="{024AFBE9-CB00-4224-8C5A-C8EE5315BE0C}"/>
                    </a:ext>
                  </a:extLst>
                </p:cNvPr>
                <p:cNvSpPr/>
                <p:nvPr/>
              </p:nvSpPr>
              <p:spPr>
                <a:xfrm>
                  <a:off x="2871671" y="2241023"/>
                  <a:ext cx="296560" cy="1501187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4BA297F5-BE87-4CED-AC30-0FC832BE5536}"/>
                    </a:ext>
                  </a:extLst>
                </p:cNvPr>
                <p:cNvSpPr/>
                <p:nvPr/>
              </p:nvSpPr>
              <p:spPr>
                <a:xfrm>
                  <a:off x="3763240" y="1539654"/>
                  <a:ext cx="296560" cy="220255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Rectangle 19">
                  <a:extLst>
                    <a:ext uri="{FF2B5EF4-FFF2-40B4-BE49-F238E27FC236}">
                      <a16:creationId xmlns:a16="http://schemas.microsoft.com/office/drawing/2014/main" id="{1DB22DB4-E61C-47BC-AE38-879BC943CD65}"/>
                    </a:ext>
                  </a:extLst>
                </p:cNvPr>
                <p:cNvSpPr/>
                <p:nvPr/>
              </p:nvSpPr>
              <p:spPr>
                <a:xfrm>
                  <a:off x="4657053" y="3681187"/>
                  <a:ext cx="296560" cy="45719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B496A49C-77C3-4195-BDD0-B33236960AB1}"/>
                    </a:ext>
                  </a:extLst>
                </p:cNvPr>
                <p:cNvSpPr txBox="1"/>
                <p:nvPr/>
              </p:nvSpPr>
              <p:spPr>
                <a:xfrm>
                  <a:off x="1671314" y="2932719"/>
                  <a:ext cx="525521" cy="3225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,000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65B8CE68-A0B8-484C-A383-741DED881ADF}"/>
                    </a:ext>
                  </a:extLst>
                </p:cNvPr>
                <p:cNvSpPr txBox="1"/>
                <p:nvPr/>
              </p:nvSpPr>
              <p:spPr>
                <a:xfrm>
                  <a:off x="1564278" y="1523020"/>
                  <a:ext cx="57259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,000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E311D5DE-43F0-46DF-951B-448322150D7D}"/>
                    </a:ext>
                  </a:extLst>
                </p:cNvPr>
                <p:cNvSpPr txBox="1"/>
                <p:nvPr/>
              </p:nvSpPr>
              <p:spPr>
                <a:xfrm>
                  <a:off x="1554180" y="2213013"/>
                  <a:ext cx="57259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,000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FF723243-F84F-43E4-844F-3602BCE017A5}"/>
                    </a:ext>
                  </a:extLst>
                </p:cNvPr>
                <p:cNvSpPr txBox="1"/>
                <p:nvPr/>
              </p:nvSpPr>
              <p:spPr>
                <a:xfrm>
                  <a:off x="1564278" y="858047"/>
                  <a:ext cx="57259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,000</a:t>
                  </a:r>
                </a:p>
              </p:txBody>
            </p:sp>
            <p:cxnSp>
              <p:nvCxnSpPr>
                <p:cNvPr id="48" name="Straight Connector 47">
                  <a:extLst>
                    <a:ext uri="{FF2B5EF4-FFF2-40B4-BE49-F238E27FC236}">
                      <a16:creationId xmlns:a16="http://schemas.microsoft.com/office/drawing/2014/main" id="{C215F1EE-3E5A-41E8-92C5-6A89A5C20267}"/>
                    </a:ext>
                  </a:extLst>
                </p:cNvPr>
                <p:cNvCxnSpPr/>
                <p:nvPr/>
              </p:nvCxnSpPr>
              <p:spPr>
                <a:xfrm>
                  <a:off x="2123704" y="3057291"/>
                  <a:ext cx="12573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Connector 48">
                  <a:extLst>
                    <a:ext uri="{FF2B5EF4-FFF2-40B4-BE49-F238E27FC236}">
                      <a16:creationId xmlns:a16="http://schemas.microsoft.com/office/drawing/2014/main" id="{C2B9966D-4BA9-4B6C-BD58-E42862EEA7EE}"/>
                    </a:ext>
                  </a:extLst>
                </p:cNvPr>
                <p:cNvCxnSpPr/>
                <p:nvPr/>
              </p:nvCxnSpPr>
              <p:spPr>
                <a:xfrm>
                  <a:off x="2104607" y="2367297"/>
                  <a:ext cx="12573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Straight Connector 49">
                  <a:extLst>
                    <a:ext uri="{FF2B5EF4-FFF2-40B4-BE49-F238E27FC236}">
                      <a16:creationId xmlns:a16="http://schemas.microsoft.com/office/drawing/2014/main" id="{4058A79F-2399-4943-A6AC-6E37766A4A0C}"/>
                    </a:ext>
                  </a:extLst>
                </p:cNvPr>
                <p:cNvCxnSpPr/>
                <p:nvPr/>
              </p:nvCxnSpPr>
              <p:spPr>
                <a:xfrm>
                  <a:off x="2123704" y="1669952"/>
                  <a:ext cx="12573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id="{B00F3768-02C2-416C-9DC0-9C5BCF6ACC1D}"/>
                    </a:ext>
                  </a:extLst>
                </p:cNvPr>
                <p:cNvCxnSpPr/>
                <p:nvPr/>
              </p:nvCxnSpPr>
              <p:spPr>
                <a:xfrm>
                  <a:off x="2118284" y="995188"/>
                  <a:ext cx="12573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Connector 51">
                  <a:extLst>
                    <a:ext uri="{FF2B5EF4-FFF2-40B4-BE49-F238E27FC236}">
                      <a16:creationId xmlns:a16="http://schemas.microsoft.com/office/drawing/2014/main" id="{649A79E7-D48D-4F72-96EC-26AE6669181F}"/>
                    </a:ext>
                  </a:extLst>
                </p:cNvPr>
                <p:cNvCxnSpPr/>
                <p:nvPr/>
              </p:nvCxnSpPr>
              <p:spPr>
                <a:xfrm>
                  <a:off x="2123546" y="3726906"/>
                  <a:ext cx="12573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920005C6-8F29-49FE-A4E6-7AC7D94725C5}"/>
                    </a:ext>
                  </a:extLst>
                </p:cNvPr>
                <p:cNvSpPr txBox="1"/>
                <p:nvPr/>
              </p:nvSpPr>
              <p:spPr>
                <a:xfrm>
                  <a:off x="1900836" y="3572094"/>
                  <a:ext cx="25519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EAE6CC3F-DCB3-4B48-B43B-1BB9DF22064B}"/>
                    </a:ext>
                  </a:extLst>
                </p:cNvPr>
                <p:cNvSpPr txBox="1"/>
                <p:nvPr/>
              </p:nvSpPr>
              <p:spPr>
                <a:xfrm rot="18667124">
                  <a:off x="2233363" y="4064164"/>
                  <a:ext cx="1186708" cy="38659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DNA3.1(+)/</a:t>
                  </a:r>
                </a:p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L4-3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618D6F10-84CA-4B62-83ED-76C446017B99}"/>
                    </a:ext>
                  </a:extLst>
                </p:cNvPr>
                <p:cNvSpPr txBox="1"/>
                <p:nvPr/>
              </p:nvSpPr>
              <p:spPr>
                <a:xfrm rot="18647105">
                  <a:off x="3521390" y="3884212"/>
                  <a:ext cx="661803" cy="38659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-HA/</a:t>
                  </a:r>
                </a:p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L4-3</a:t>
                  </a:r>
                </a:p>
              </p:txBody>
            </p:sp>
          </p:grp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CA93890C-3156-46A9-B33D-CFCCA08F80F9}"/>
                  </a:ext>
                </a:extLst>
              </p:cNvPr>
              <p:cNvSpPr txBox="1"/>
              <p:nvPr/>
            </p:nvSpPr>
            <p:spPr>
              <a:xfrm rot="18504171">
                <a:off x="4061992" y="3933170"/>
                <a:ext cx="1144714" cy="3865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cDNA3.1(+)</a:t>
                </a:r>
              </a:p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lone</a:t>
                </a:r>
              </a:p>
            </p:txBody>
          </p:sp>
        </p:grp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20CCE18-F823-49BE-A784-B0258ABE4163}"/>
                </a:ext>
              </a:extLst>
            </p:cNvPr>
            <p:cNvSpPr txBox="1"/>
            <p:nvPr/>
          </p:nvSpPr>
          <p:spPr>
            <a:xfrm>
              <a:off x="928225" y="4354258"/>
              <a:ext cx="381220" cy="4031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708CFDE0-0D4C-4D13-A2E0-03401277E5C7}"/>
              </a:ext>
            </a:extLst>
          </p:cNvPr>
          <p:cNvGrpSpPr/>
          <p:nvPr/>
        </p:nvGrpSpPr>
        <p:grpSpPr>
          <a:xfrm>
            <a:off x="1175547" y="739508"/>
            <a:ext cx="4307500" cy="3000604"/>
            <a:chOff x="901472" y="533154"/>
            <a:chExt cx="4307501" cy="4079237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FDFE057-CEE1-484B-AE5B-FC8FDAE650D7}"/>
                </a:ext>
              </a:extLst>
            </p:cNvPr>
            <p:cNvSpPr txBox="1"/>
            <p:nvPr/>
          </p:nvSpPr>
          <p:spPr>
            <a:xfrm>
              <a:off x="3496984" y="56699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5</a:t>
              </a:r>
            </a:p>
          </p:txBody>
        </p: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CDED4785-DE31-4C8F-8D3F-93EC413AB9A0}"/>
                </a:ext>
              </a:extLst>
            </p:cNvPr>
            <p:cNvGrpSpPr/>
            <p:nvPr/>
          </p:nvGrpSpPr>
          <p:grpSpPr>
            <a:xfrm>
              <a:off x="901472" y="533154"/>
              <a:ext cx="4307501" cy="4079237"/>
              <a:chOff x="894736" y="530367"/>
              <a:chExt cx="4779499" cy="4612531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A9AB2019-DD01-4A45-9AB9-03361A1CD692}"/>
                  </a:ext>
                </a:extLst>
              </p:cNvPr>
              <p:cNvGrpSpPr/>
              <p:nvPr/>
            </p:nvGrpSpPr>
            <p:grpSpPr>
              <a:xfrm>
                <a:off x="1496593" y="530367"/>
                <a:ext cx="4177642" cy="4612531"/>
                <a:chOff x="1399331" y="4440741"/>
                <a:chExt cx="4177642" cy="4612531"/>
              </a:xfrm>
            </p:grpSpPr>
            <p:grpSp>
              <p:nvGrpSpPr>
                <p:cNvPr id="3" name="Group 2">
                  <a:extLst>
                    <a:ext uri="{FF2B5EF4-FFF2-40B4-BE49-F238E27FC236}">
                      <a16:creationId xmlns:a16="http://schemas.microsoft.com/office/drawing/2014/main" id="{2525D67C-D5D2-4A91-B038-584D806CF36F}"/>
                    </a:ext>
                  </a:extLst>
                </p:cNvPr>
                <p:cNvGrpSpPr/>
                <p:nvPr/>
              </p:nvGrpSpPr>
              <p:grpSpPr>
                <a:xfrm>
                  <a:off x="1399331" y="4440741"/>
                  <a:ext cx="4177642" cy="4612531"/>
                  <a:chOff x="1399331" y="4440741"/>
                  <a:chExt cx="4177642" cy="4612531"/>
                </a:xfrm>
              </p:grpSpPr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8945E200-AE29-4C7B-B856-4201379AFBF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202800" y="6042872"/>
                    <a:ext cx="3648214" cy="4439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u-gag copies :% relative to control  </a:t>
                    </a:r>
                  </a:p>
                </p:txBody>
              </p:sp>
              <p:grpSp>
                <p:nvGrpSpPr>
                  <p:cNvPr id="9" name="Group 8">
                    <a:extLst>
                      <a:ext uri="{FF2B5EF4-FFF2-40B4-BE49-F238E27FC236}">
                        <a16:creationId xmlns:a16="http://schemas.microsoft.com/office/drawing/2014/main" id="{E333E807-5240-4A35-8201-9F5B0E2E6935}"/>
                      </a:ext>
                    </a:extLst>
                  </p:cNvPr>
                  <p:cNvGrpSpPr/>
                  <p:nvPr/>
                </p:nvGrpSpPr>
                <p:grpSpPr>
                  <a:xfrm>
                    <a:off x="1725656" y="4658456"/>
                    <a:ext cx="3851317" cy="4394816"/>
                    <a:chOff x="1091385" y="4303447"/>
                    <a:chExt cx="3851317" cy="4394816"/>
                  </a:xfrm>
                </p:grpSpPr>
                <p:cxnSp>
                  <p:nvCxnSpPr>
                    <p:cNvPr id="15" name="Straight Connector 14">
                      <a:extLst>
                        <a:ext uri="{FF2B5EF4-FFF2-40B4-BE49-F238E27FC236}">
                          <a16:creationId xmlns:a16="http://schemas.microsoft.com/office/drawing/2014/main" id="{A77A2C3C-8CAE-4AD8-B5DB-C38158C2335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606378" y="4490830"/>
                      <a:ext cx="0" cy="2841463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" name="Straight Connector 15">
                      <a:extLst>
                        <a:ext uri="{FF2B5EF4-FFF2-40B4-BE49-F238E27FC236}">
                          <a16:creationId xmlns:a16="http://schemas.microsoft.com/office/drawing/2014/main" id="{EC0FBE3E-EE7C-434D-B5B6-0E1CE5AA22D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606378" y="7309433"/>
                      <a:ext cx="3336324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3" name="Rectangle 22">
                      <a:extLst>
                        <a:ext uri="{FF2B5EF4-FFF2-40B4-BE49-F238E27FC236}">
                          <a16:creationId xmlns:a16="http://schemas.microsoft.com/office/drawing/2014/main" id="{B70E7703-4C5E-418A-9931-A829BF9A8CD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247044" y="4735729"/>
                      <a:ext cx="296560" cy="2566085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24" name="Rectangle 23">
                      <a:extLst>
                        <a:ext uri="{FF2B5EF4-FFF2-40B4-BE49-F238E27FC236}">
                          <a16:creationId xmlns:a16="http://schemas.microsoft.com/office/drawing/2014/main" id="{B6177BAC-EAD1-43A6-A37A-6D8A7078053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60431" y="4617540"/>
                      <a:ext cx="296560" cy="2691893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25" name="Rectangle 24">
                      <a:extLst>
                        <a:ext uri="{FF2B5EF4-FFF2-40B4-BE49-F238E27FC236}">
                          <a16:creationId xmlns:a16="http://schemas.microsoft.com/office/drawing/2014/main" id="{8D257DA0-D866-4B17-B704-D0FE278BF70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36547" y="7266092"/>
                      <a:ext cx="296560" cy="45719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3" name="TextBox 32">
                      <a:extLst>
                        <a:ext uri="{FF2B5EF4-FFF2-40B4-BE49-F238E27FC236}">
                          <a16:creationId xmlns:a16="http://schemas.microsoft.com/office/drawing/2014/main" id="{4AFCF69E-64DF-49C4-9F47-FB3F96B676A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91385" y="4574005"/>
                      <a:ext cx="39626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p:txBody>
                </p:sp>
                <p:cxnSp>
                  <p:nvCxnSpPr>
                    <p:cNvPr id="4" name="Straight Connector 3">
                      <a:extLst>
                        <a:ext uri="{FF2B5EF4-FFF2-40B4-BE49-F238E27FC236}">
                          <a16:creationId xmlns:a16="http://schemas.microsoft.com/office/drawing/2014/main" id="{B93068B0-C78E-4AAF-8AB7-506526FA0C8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480648" y="7310360"/>
                      <a:ext cx="125730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" name="Straight Connector 33">
                      <a:extLst>
                        <a:ext uri="{FF2B5EF4-FFF2-40B4-BE49-F238E27FC236}">
                          <a16:creationId xmlns:a16="http://schemas.microsoft.com/office/drawing/2014/main" id="{F2F19E7D-A61A-4EC6-BA2C-7D1A10EB242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487647" y="6773150"/>
                      <a:ext cx="125730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" name="Straight Connector 34">
                      <a:extLst>
                        <a:ext uri="{FF2B5EF4-FFF2-40B4-BE49-F238E27FC236}">
                          <a16:creationId xmlns:a16="http://schemas.microsoft.com/office/drawing/2014/main" id="{FD24DC61-B91D-4E98-A105-B9086011DFF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499540" y="6224510"/>
                      <a:ext cx="125730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" name="Straight Connector 35">
                      <a:extLst>
                        <a:ext uri="{FF2B5EF4-FFF2-40B4-BE49-F238E27FC236}">
                          <a16:creationId xmlns:a16="http://schemas.microsoft.com/office/drawing/2014/main" id="{38A74622-3B63-405F-90AD-B95A6A17053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499540" y="5767310"/>
                      <a:ext cx="125730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" name="Straight Connector 36">
                      <a:extLst>
                        <a:ext uri="{FF2B5EF4-FFF2-40B4-BE49-F238E27FC236}">
                          <a16:creationId xmlns:a16="http://schemas.microsoft.com/office/drawing/2014/main" id="{668C01CA-09F5-4A40-A3B2-BAB64A50753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499540" y="5310110"/>
                      <a:ext cx="125730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" name="Straight Connector 37">
                      <a:extLst>
                        <a:ext uri="{FF2B5EF4-FFF2-40B4-BE49-F238E27FC236}">
                          <a16:creationId xmlns:a16="http://schemas.microsoft.com/office/drawing/2014/main" id="{AF9A98EB-517F-4CFE-8FE8-E0D3B4E50BA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499077" y="4757660"/>
                      <a:ext cx="125730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9" name="TextBox 38">
                      <a:extLst>
                        <a:ext uri="{FF2B5EF4-FFF2-40B4-BE49-F238E27FC236}">
                          <a16:creationId xmlns:a16="http://schemas.microsoft.com/office/drawing/2014/main" id="{91565165-A279-4DD4-87E0-8969E46C071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85217" y="5137689"/>
                      <a:ext cx="32573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</a:t>
                      </a:r>
                    </a:p>
                  </p:txBody>
                </p:sp>
                <p:sp>
                  <p:nvSpPr>
                    <p:cNvPr id="40" name="TextBox 39">
                      <a:extLst>
                        <a:ext uri="{FF2B5EF4-FFF2-40B4-BE49-F238E27FC236}">
                          <a16:creationId xmlns:a16="http://schemas.microsoft.com/office/drawing/2014/main" id="{A6139A13-0962-47FC-8EDE-AA85A978799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76817" y="5561949"/>
                      <a:ext cx="32573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p:txBody>
                </p:sp>
                <p:sp>
                  <p:nvSpPr>
                    <p:cNvPr id="41" name="TextBox 40">
                      <a:extLst>
                        <a:ext uri="{FF2B5EF4-FFF2-40B4-BE49-F238E27FC236}">
                          <a16:creationId xmlns:a16="http://schemas.microsoft.com/office/drawing/2014/main" id="{7B58EC40-1B2E-474B-9046-99E964C98EF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89312" y="6032074"/>
                      <a:ext cx="32573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p:txBody>
                </p:sp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F2A0F84A-6862-4248-A701-7BC63D258D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02432" y="6608475"/>
                      <a:ext cx="32573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p:txBody>
                </p:sp>
                <p:sp>
                  <p:nvSpPr>
                    <p:cNvPr id="43" name="TextBox 42">
                      <a:extLst>
                        <a:ext uri="{FF2B5EF4-FFF2-40B4-BE49-F238E27FC236}">
                          <a16:creationId xmlns:a16="http://schemas.microsoft.com/office/drawing/2014/main" id="{5305E262-A920-42A3-A7D7-DB1D52258D2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80416" y="7124260"/>
                      <a:ext cx="25519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p:txBody>
                </p:sp>
                <p:sp>
                  <p:nvSpPr>
                    <p:cNvPr id="44" name="TextBox 43">
                      <a:extLst>
                        <a:ext uri="{FF2B5EF4-FFF2-40B4-BE49-F238E27FC236}">
                          <a16:creationId xmlns:a16="http://schemas.microsoft.com/office/drawing/2014/main" id="{4B5C148F-E007-4CBB-98E1-A90C2C280EB4}"/>
                        </a:ext>
                      </a:extLst>
                    </p:cNvPr>
                    <p:cNvSpPr txBox="1"/>
                    <p:nvPr/>
                  </p:nvSpPr>
                  <p:spPr>
                    <a:xfrm rot="18367165">
                      <a:off x="3377451" y="7720158"/>
                      <a:ext cx="1392732" cy="5634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DNA3.1(+)/</a:t>
                      </a:r>
                    </a:p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4-3/</a:t>
                      </a:r>
                    </a:p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tegravir</a:t>
                      </a:r>
                    </a:p>
                  </p:txBody>
                </p:sp>
                <p:sp>
                  <p:nvSpPr>
                    <p:cNvPr id="45" name="TextBox 44">
                      <a:extLst>
                        <a:ext uri="{FF2B5EF4-FFF2-40B4-BE49-F238E27FC236}">
                          <a16:creationId xmlns:a16="http://schemas.microsoft.com/office/drawing/2014/main" id="{3F61CD9F-54F0-496E-A2C7-CC84E0C8B45C}"/>
                        </a:ext>
                      </a:extLst>
                    </p:cNvPr>
                    <p:cNvSpPr txBox="1"/>
                    <p:nvPr/>
                  </p:nvSpPr>
                  <p:spPr>
                    <a:xfrm rot="18371010">
                      <a:off x="2893978" y="7472321"/>
                      <a:ext cx="776697" cy="40980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-HA/</a:t>
                      </a:r>
                    </a:p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4-3</a:t>
                      </a:r>
                    </a:p>
                  </p:txBody>
                </p:sp>
                <p:sp>
                  <p:nvSpPr>
                    <p:cNvPr id="47" name="TextBox 46">
                      <a:extLst>
                        <a:ext uri="{FF2B5EF4-FFF2-40B4-BE49-F238E27FC236}">
                          <a16:creationId xmlns:a16="http://schemas.microsoft.com/office/drawing/2014/main" id="{0FF96000-7B12-4263-A6FD-E84ECB86C9C9}"/>
                        </a:ext>
                      </a:extLst>
                    </p:cNvPr>
                    <p:cNvSpPr txBox="1"/>
                    <p:nvPr/>
                  </p:nvSpPr>
                  <p:spPr>
                    <a:xfrm rot="18519117">
                      <a:off x="1483105" y="7695397"/>
                      <a:ext cx="1392730" cy="40980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DNA3.1(+)/</a:t>
                      </a:r>
                    </a:p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4-3</a:t>
                      </a:r>
                    </a:p>
                  </p:txBody>
                </p:sp>
                <p:sp>
                  <p:nvSpPr>
                    <p:cNvPr id="65" name="TextBox 64">
                      <a:extLst>
                        <a:ext uri="{FF2B5EF4-FFF2-40B4-BE49-F238E27FC236}">
                          <a16:creationId xmlns:a16="http://schemas.microsoft.com/office/drawing/2014/main" id="{579A8181-5A38-4650-A0A9-4FEA96BC7B0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98352" y="4303447"/>
                      <a:ext cx="39626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</a:t>
                      </a:r>
                    </a:p>
                  </p:txBody>
                </p:sp>
                <p:cxnSp>
                  <p:nvCxnSpPr>
                    <p:cNvPr id="66" name="Straight Connector 65">
                      <a:extLst>
                        <a:ext uri="{FF2B5EF4-FFF2-40B4-BE49-F238E27FC236}">
                          <a16:creationId xmlns:a16="http://schemas.microsoft.com/office/drawing/2014/main" id="{76ACB260-CE85-43F7-9F7A-884B29F95F3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499939" y="4490830"/>
                      <a:ext cx="125731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6DEB01A7-AA4B-46F0-B7AB-1B0E1B0BDA4D}"/>
                    </a:ext>
                  </a:extLst>
                </p:cNvPr>
                <p:cNvSpPr txBox="1"/>
                <p:nvPr/>
              </p:nvSpPr>
              <p:spPr>
                <a:xfrm>
                  <a:off x="4620163" y="7017090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1</a:t>
                  </a:r>
                </a:p>
              </p:txBody>
            </p:sp>
          </p:grp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51F06D95-9AA9-4A59-AC07-C962F650CAD8}"/>
                  </a:ext>
                </a:extLst>
              </p:cNvPr>
              <p:cNvSpPr txBox="1"/>
              <p:nvPr/>
            </p:nvSpPr>
            <p:spPr>
              <a:xfrm>
                <a:off x="894736" y="535355"/>
                <a:ext cx="427233" cy="6150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BD2400F0-5716-4D78-8B00-6895C991EBD2}"/>
                </a:ext>
              </a:extLst>
            </p:cNvPr>
            <p:cNvGrpSpPr/>
            <p:nvPr/>
          </p:nvGrpSpPr>
          <p:grpSpPr>
            <a:xfrm>
              <a:off x="3637842" y="908311"/>
              <a:ext cx="190500" cy="128983"/>
              <a:chOff x="5133528" y="2640436"/>
              <a:chExt cx="190500" cy="470054"/>
            </a:xfrm>
          </p:grpSpPr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C983E66C-3223-47C7-B74D-B76A7489108F}"/>
                  </a:ext>
                </a:extLst>
              </p:cNvPr>
              <p:cNvCxnSpPr/>
              <p:nvPr/>
            </p:nvCxnSpPr>
            <p:spPr>
              <a:xfrm>
                <a:off x="5133528" y="2656314"/>
                <a:ext cx="1905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86636D64-7793-47D9-8539-AE2EA9B1FE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28778" y="2640436"/>
                <a:ext cx="0" cy="47005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FE71F7BA-13A8-4FE2-8684-FEF3C469A1F0}"/>
                </a:ext>
              </a:extLst>
            </p:cNvPr>
            <p:cNvGrpSpPr/>
            <p:nvPr/>
          </p:nvGrpSpPr>
          <p:grpSpPr>
            <a:xfrm>
              <a:off x="4440503" y="3304179"/>
              <a:ext cx="190500" cy="44922"/>
              <a:chOff x="5050580" y="-1235247"/>
              <a:chExt cx="190500" cy="470055"/>
            </a:xfrm>
          </p:grpSpPr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DC1E863A-5AE2-4667-AFCB-B7626FB5A206}"/>
                  </a:ext>
                </a:extLst>
              </p:cNvPr>
              <p:cNvCxnSpPr/>
              <p:nvPr/>
            </p:nvCxnSpPr>
            <p:spPr>
              <a:xfrm>
                <a:off x="5050580" y="-1235247"/>
                <a:ext cx="1905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CC9DB039-7FE8-4AD6-8708-457D26039F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45830" y="-1235247"/>
                <a:ext cx="0" cy="470055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F43C0160-803D-4448-BC76-8474AE842244}"/>
              </a:ext>
            </a:extLst>
          </p:cNvPr>
          <p:cNvGrpSpPr/>
          <p:nvPr/>
        </p:nvGrpSpPr>
        <p:grpSpPr>
          <a:xfrm>
            <a:off x="3199619" y="4732690"/>
            <a:ext cx="190500" cy="241860"/>
            <a:chOff x="5440680" y="2739390"/>
            <a:chExt cx="190500" cy="478395"/>
          </a:xfrm>
        </p:grpSpPr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CC6E1169-5896-4951-8B7A-5692C43B358B}"/>
                </a:ext>
              </a:extLst>
            </p:cNvPr>
            <p:cNvCxnSpPr/>
            <p:nvPr/>
          </p:nvCxnSpPr>
          <p:spPr>
            <a:xfrm>
              <a:off x="5440680" y="2739390"/>
              <a:ext cx="1905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8DA13613-E666-4DED-8ADB-A63A63661423}"/>
                </a:ext>
              </a:extLst>
            </p:cNvPr>
            <p:cNvCxnSpPr>
              <a:cxnSpLocks/>
            </p:cNvCxnSpPr>
            <p:nvPr/>
          </p:nvCxnSpPr>
          <p:spPr>
            <a:xfrm>
              <a:off x="5533494" y="2747733"/>
              <a:ext cx="0" cy="470052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6B089802-ACE2-4FC1-89F0-982C78AB0F96}"/>
              </a:ext>
            </a:extLst>
          </p:cNvPr>
          <p:cNvGrpSpPr/>
          <p:nvPr/>
        </p:nvGrpSpPr>
        <p:grpSpPr>
          <a:xfrm>
            <a:off x="4037240" y="4222052"/>
            <a:ext cx="190500" cy="241860"/>
            <a:chOff x="5440680" y="2739390"/>
            <a:chExt cx="190500" cy="478395"/>
          </a:xfrm>
        </p:grpSpPr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26B04F39-BFC8-44F8-8F93-790E2FADFC8D}"/>
                </a:ext>
              </a:extLst>
            </p:cNvPr>
            <p:cNvCxnSpPr/>
            <p:nvPr/>
          </p:nvCxnSpPr>
          <p:spPr>
            <a:xfrm>
              <a:off x="5440680" y="2739390"/>
              <a:ext cx="1905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A5EC7434-46ED-4F59-864C-0AE69D23D125}"/>
                </a:ext>
              </a:extLst>
            </p:cNvPr>
            <p:cNvCxnSpPr>
              <a:cxnSpLocks/>
            </p:cNvCxnSpPr>
            <p:nvPr/>
          </p:nvCxnSpPr>
          <p:spPr>
            <a:xfrm>
              <a:off x="5533494" y="2747733"/>
              <a:ext cx="0" cy="470052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F4827A3B-5785-4982-A7ED-01EAA1CC6D0B}"/>
              </a:ext>
            </a:extLst>
          </p:cNvPr>
          <p:cNvSpPr txBox="1"/>
          <p:nvPr/>
        </p:nvSpPr>
        <p:spPr>
          <a:xfrm>
            <a:off x="437556" y="8401247"/>
            <a:ext cx="1967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4.</a:t>
            </a:r>
          </a:p>
        </p:txBody>
      </p:sp>
      <p:sp>
        <p:nvSpPr>
          <p:cNvPr id="46" name="Isosceles Triangle 45">
            <a:extLst>
              <a:ext uri="{FF2B5EF4-FFF2-40B4-BE49-F238E27FC236}">
                <a16:creationId xmlns:a16="http://schemas.microsoft.com/office/drawing/2014/main" id="{0D329DD9-D702-4434-A8B0-A9E24130B825}"/>
              </a:ext>
            </a:extLst>
          </p:cNvPr>
          <p:cNvSpPr/>
          <p:nvPr/>
        </p:nvSpPr>
        <p:spPr>
          <a:xfrm>
            <a:off x="3172898" y="4505229"/>
            <a:ext cx="155628" cy="14570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Isosceles Triangle 69">
            <a:extLst>
              <a:ext uri="{FF2B5EF4-FFF2-40B4-BE49-F238E27FC236}">
                <a16:creationId xmlns:a16="http://schemas.microsoft.com/office/drawing/2014/main" id="{F35AB956-119D-4E66-8DFE-3736DB3B8D42}"/>
              </a:ext>
            </a:extLst>
          </p:cNvPr>
          <p:cNvSpPr/>
          <p:nvPr/>
        </p:nvSpPr>
        <p:spPr>
          <a:xfrm>
            <a:off x="4046379" y="3983885"/>
            <a:ext cx="155628" cy="14570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306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</TotalTime>
  <Words>58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 Stephens</dc:creator>
  <cp:lastModifiedBy>Edward Stephens</cp:lastModifiedBy>
  <cp:revision>16</cp:revision>
  <dcterms:created xsi:type="dcterms:W3CDTF">2021-07-16T19:47:40Z</dcterms:created>
  <dcterms:modified xsi:type="dcterms:W3CDTF">2022-10-14T16:37:54Z</dcterms:modified>
</cp:coreProperties>
</file>